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09"/>
    <p:restoredTop sz="94699"/>
  </p:normalViewPr>
  <p:slideViewPr>
    <p:cSldViewPr snapToGrid="0" snapToObjects="1">
      <p:cViewPr>
        <p:scale>
          <a:sx n="110" d="100"/>
          <a:sy n="110" d="100"/>
        </p:scale>
        <p:origin x="2448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localhost//Users/jourdanmichel/Documents/2017%20B%20cell%20differentiation/2017%20FCRL4/S2%20Figure%20rev/Classeur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localhost//Users/jourdanmichel/Documents/2017%20B%20cell%20differentiation/2017%20FCRL4/S2%20Figure%20rev/Classeur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localhost//Users/jourdanmichel/Documents/2017%20B%20cell%20differentiation/2017%20FCRL4/S2%20Figure%20rev/Classeur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localhost//Users/jourdanmichel/Documents/2017%20B%20cell%20differentiation/2017%20FCRL4/S2%20Figure%20rev/Classeur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microsoft.com/office/2011/relationships/chartStyle" Target="style5.xml"/><Relationship Id="rId2" Type="http://schemas.microsoft.com/office/2011/relationships/chartColorStyle" Target="colors5.xml"/><Relationship Id="rId3" Type="http://schemas.openxmlformats.org/officeDocument/2006/relationships/oleObject" Target="file://localhost//Users/jourdanmichel/Documents/2017%20B%20cell%20differentiation/2017%20FCRL4/S2%20Figure%20rev/Classeur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lasseur1.xlsx]Tri J1 rev'!$Q$49:$S$49</c:f>
                <c:numCache>
                  <c:formatCode>General</c:formatCode>
                  <c:ptCount val="3"/>
                  <c:pt idx="0">
                    <c:v>7.11500000000001</c:v>
                  </c:pt>
                  <c:pt idx="1">
                    <c:v>4.950000000000005</c:v>
                  </c:pt>
                  <c:pt idx="2">
                    <c:v>2.204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lasseur1.xlsx]Tri J1 rev'!$Q$45:$S$45</c:f>
              <c:strCache>
                <c:ptCount val="3"/>
                <c:pt idx="0">
                  <c:v>IgM</c:v>
                </c:pt>
                <c:pt idx="1">
                  <c:v>IgA</c:v>
                </c:pt>
                <c:pt idx="2">
                  <c:v>IgG</c:v>
                </c:pt>
              </c:strCache>
            </c:strRef>
          </c:cat>
          <c:val>
            <c:numRef>
              <c:f>'[Classeur1.xlsx]Tri J1 rev'!$Q$48:$S$48</c:f>
              <c:numCache>
                <c:formatCode>0.0</c:formatCode>
                <c:ptCount val="3"/>
                <c:pt idx="0">
                  <c:v>31.805</c:v>
                </c:pt>
                <c:pt idx="1">
                  <c:v>23.52</c:v>
                </c:pt>
                <c:pt idx="2">
                  <c:v>41.125</c:v>
                </c:pt>
              </c:numCache>
            </c:numRef>
          </c:val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lasseur1.xlsx]Tri J1 rev'!$Q$55:$S$55</c:f>
                <c:numCache>
                  <c:formatCode>General</c:formatCode>
                  <c:ptCount val="3"/>
                  <c:pt idx="0">
                    <c:v>5.070000000000001</c:v>
                  </c:pt>
                  <c:pt idx="1">
                    <c:v>3.239999999999988</c:v>
                  </c:pt>
                  <c:pt idx="2">
                    <c:v>2.824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lasseur1.xlsx]Tri J1 rev'!$Q$45:$S$45</c:f>
              <c:strCache>
                <c:ptCount val="3"/>
                <c:pt idx="0">
                  <c:v>IgM</c:v>
                </c:pt>
                <c:pt idx="1">
                  <c:v>IgA</c:v>
                </c:pt>
                <c:pt idx="2">
                  <c:v>IgG</c:v>
                </c:pt>
              </c:strCache>
            </c:strRef>
          </c:cat>
          <c:val>
            <c:numRef>
              <c:f>'[Classeur1.xlsx]Tri J1 rev'!$Q$54:$S$54</c:f>
              <c:numCache>
                <c:formatCode>0.0</c:formatCode>
                <c:ptCount val="3"/>
                <c:pt idx="0">
                  <c:v>12.06</c:v>
                </c:pt>
                <c:pt idx="1">
                  <c:v>22.96</c:v>
                </c:pt>
                <c:pt idx="2">
                  <c:v>60.5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644789808"/>
        <c:axId val="-644788032"/>
      </c:barChart>
      <c:catAx>
        <c:axId val="-644789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4788032"/>
        <c:crosses val="autoZero"/>
        <c:auto val="1"/>
        <c:lblAlgn val="ctr"/>
        <c:lblOffset val="100"/>
        <c:noMultiLvlLbl val="0"/>
      </c:catAx>
      <c:valAx>
        <c:axId val="-644788032"/>
        <c:scaling>
          <c:orientation val="minMax"/>
        </c:scaling>
        <c:delete val="0"/>
        <c:axPos val="l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4789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1-sorted FCRL4+ cells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[Classeur1.xlsx]Tri J1 rev'!$B$49:$G$49</c:f>
                <c:numCache>
                  <c:formatCode>General</c:formatCode>
                  <c:ptCount val="6"/>
                  <c:pt idx="0">
                    <c:v>4.885000000000005</c:v>
                  </c:pt>
                  <c:pt idx="2">
                    <c:v>1.0</c:v>
                  </c:pt>
                  <c:pt idx="3">
                    <c:v>0.32</c:v>
                  </c:pt>
                  <c:pt idx="4">
                    <c:v>0.5</c:v>
                  </c:pt>
                  <c:pt idx="5">
                    <c:v>0.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lasseur1.xlsx]Tri J1 rev'!$B$45:$G$45</c:f>
              <c:strCache>
                <c:ptCount val="6"/>
                <c:pt idx="0">
                  <c:v>D1-unsorted cells</c:v>
                </c:pt>
                <c:pt idx="2">
                  <c:v>D1</c:v>
                </c:pt>
                <c:pt idx="3">
                  <c:v>D4</c:v>
                </c:pt>
                <c:pt idx="4">
                  <c:v>D7</c:v>
                </c:pt>
                <c:pt idx="5">
                  <c:v>D10</c:v>
                </c:pt>
              </c:strCache>
            </c:strRef>
          </c:cat>
          <c:val>
            <c:numRef>
              <c:f>'[Classeur1.xlsx]Tri J1 rev'!$B$48:$G$48</c:f>
              <c:numCache>
                <c:formatCode>General</c:formatCode>
                <c:ptCount val="6"/>
                <c:pt idx="0" formatCode="0.0">
                  <c:v>68.905</c:v>
                </c:pt>
                <c:pt idx="2" formatCode="0.0">
                  <c:v>98.0</c:v>
                </c:pt>
                <c:pt idx="3" formatCode="0.0">
                  <c:v>34.89</c:v>
                </c:pt>
                <c:pt idx="4" formatCode="0.00">
                  <c:v>3.1</c:v>
                </c:pt>
                <c:pt idx="5" formatCode="0.00">
                  <c:v>0.56</c:v>
                </c:pt>
              </c:numCache>
            </c:numRef>
          </c:val>
        </c:ser>
        <c:ser>
          <c:idx val="1"/>
          <c:order val="1"/>
          <c:tx>
            <c:v>D1-sorted FCRL4- cells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lasseur1.xlsx]Tri J1 rev'!$B$55:$G$55</c:f>
                <c:numCache>
                  <c:formatCode>General</c:formatCode>
                  <c:ptCount val="6"/>
                  <c:pt idx="2">
                    <c:v>0.0</c:v>
                  </c:pt>
                  <c:pt idx="3">
                    <c:v>5.695000000000004</c:v>
                  </c:pt>
                  <c:pt idx="4">
                    <c:v>0.740000000000001</c:v>
                  </c:pt>
                  <c:pt idx="5">
                    <c:v>0.2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lasseur1.xlsx]Tri J1 rev'!$B$45:$G$45</c:f>
              <c:strCache>
                <c:ptCount val="6"/>
                <c:pt idx="0">
                  <c:v>D1-unsorted cells</c:v>
                </c:pt>
                <c:pt idx="2">
                  <c:v>D1</c:v>
                </c:pt>
                <c:pt idx="3">
                  <c:v>D4</c:v>
                </c:pt>
                <c:pt idx="4">
                  <c:v>D7</c:v>
                </c:pt>
                <c:pt idx="5">
                  <c:v>D10</c:v>
                </c:pt>
              </c:strCache>
            </c:strRef>
          </c:cat>
          <c:val>
            <c:numRef>
              <c:f>'[Classeur1.xlsx]Tri J1 rev'!$B$54:$G$54</c:f>
              <c:numCache>
                <c:formatCode>General</c:formatCode>
                <c:ptCount val="6"/>
                <c:pt idx="2">
                  <c:v>0.0</c:v>
                </c:pt>
                <c:pt idx="3" formatCode="0.00">
                  <c:v>16.955</c:v>
                </c:pt>
                <c:pt idx="4" formatCode="0.00">
                  <c:v>2.42</c:v>
                </c:pt>
                <c:pt idx="5" formatCode="0.00">
                  <c:v>0.3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1"/>
        <c:axId val="-676680016"/>
        <c:axId val="-643220224"/>
      </c:barChart>
      <c:catAx>
        <c:axId val="-676680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3220224"/>
        <c:crosses val="autoZero"/>
        <c:auto val="1"/>
        <c:lblAlgn val="ctr"/>
        <c:lblOffset val="100"/>
        <c:noMultiLvlLbl val="0"/>
      </c:catAx>
      <c:valAx>
        <c:axId val="-643220224"/>
        <c:scaling>
          <c:orientation val="minMax"/>
        </c:scaling>
        <c:delete val="0"/>
        <c:axPos val="l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76680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v>IgM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lasseur1.xlsx]Tri J1 rev'!$B$16:$I$16</c:f>
              <c:strCache>
                <c:ptCount val="8"/>
                <c:pt idx="0">
                  <c:v>FCRL4+ cells </c:v>
                </c:pt>
                <c:pt idx="1">
                  <c:v>FCRL4- cells</c:v>
                </c:pt>
                <c:pt idx="3">
                  <c:v>FCRL4+ cells </c:v>
                </c:pt>
                <c:pt idx="4">
                  <c:v>FCRL4- cells</c:v>
                </c:pt>
                <c:pt idx="6">
                  <c:v>FCRL4+ cells </c:v>
                </c:pt>
                <c:pt idx="7">
                  <c:v>FCRL4- cells</c:v>
                </c:pt>
              </c:strCache>
            </c:strRef>
          </c:cat>
          <c:val>
            <c:numRef>
              <c:f>'[Classeur1.xlsx]Tri J1 rev'!$B$17:$I$17</c:f>
              <c:numCache>
                <c:formatCode>0.0</c:formatCode>
                <c:ptCount val="8"/>
                <c:pt idx="0">
                  <c:v>69.47</c:v>
                </c:pt>
                <c:pt idx="1">
                  <c:v>53.35</c:v>
                </c:pt>
                <c:pt idx="3">
                  <c:v>46.505</c:v>
                </c:pt>
                <c:pt idx="4">
                  <c:v>53.73</c:v>
                </c:pt>
                <c:pt idx="6">
                  <c:v>0.0</c:v>
                </c:pt>
                <c:pt idx="7">
                  <c:v>36.895</c:v>
                </c:pt>
              </c:numCache>
            </c:numRef>
          </c:val>
        </c:ser>
        <c:ser>
          <c:idx val="1"/>
          <c:order val="1"/>
          <c:tx>
            <c:v>IgA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lasseur1.xlsx]Tri J1 rev'!$B$16:$I$16</c:f>
              <c:strCache>
                <c:ptCount val="8"/>
                <c:pt idx="0">
                  <c:v>FCRL4+ cells </c:v>
                </c:pt>
                <c:pt idx="1">
                  <c:v>FCRL4- cells</c:v>
                </c:pt>
                <c:pt idx="3">
                  <c:v>FCRL4+ cells </c:v>
                </c:pt>
                <c:pt idx="4">
                  <c:v>FCRL4- cells</c:v>
                </c:pt>
                <c:pt idx="6">
                  <c:v>FCRL4+ cells </c:v>
                </c:pt>
                <c:pt idx="7">
                  <c:v>FCRL4- cells</c:v>
                </c:pt>
              </c:strCache>
            </c:strRef>
          </c:cat>
          <c:val>
            <c:numRef>
              <c:f>'[Classeur1.xlsx]Tri J1 rev'!$B$18:$I$18</c:f>
              <c:numCache>
                <c:formatCode>0.0</c:formatCode>
                <c:ptCount val="8"/>
                <c:pt idx="0">
                  <c:v>21.16</c:v>
                </c:pt>
                <c:pt idx="1">
                  <c:v>26.17</c:v>
                </c:pt>
                <c:pt idx="3">
                  <c:v>42.065</c:v>
                </c:pt>
                <c:pt idx="4">
                  <c:v>25.95</c:v>
                </c:pt>
                <c:pt idx="6">
                  <c:v>0.0</c:v>
                </c:pt>
                <c:pt idx="7">
                  <c:v>28.415</c:v>
                </c:pt>
              </c:numCache>
            </c:numRef>
          </c:val>
        </c:ser>
        <c:ser>
          <c:idx val="2"/>
          <c:order val="2"/>
          <c:tx>
            <c:v>IgG</c:v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lasseur1.xlsx]Tri J1 rev'!$B$16:$I$16</c:f>
              <c:strCache>
                <c:ptCount val="8"/>
                <c:pt idx="0">
                  <c:v>FCRL4+ cells </c:v>
                </c:pt>
                <c:pt idx="1">
                  <c:v>FCRL4- cells</c:v>
                </c:pt>
                <c:pt idx="3">
                  <c:v>FCRL4+ cells </c:v>
                </c:pt>
                <c:pt idx="4">
                  <c:v>FCRL4- cells</c:v>
                </c:pt>
                <c:pt idx="6">
                  <c:v>FCRL4+ cells </c:v>
                </c:pt>
                <c:pt idx="7">
                  <c:v>FCRL4- cells</c:v>
                </c:pt>
              </c:strCache>
            </c:strRef>
          </c:cat>
          <c:val>
            <c:numRef>
              <c:f>'[Classeur1.xlsx]Tri J1 rev'!$B$19:$I$19</c:f>
              <c:numCache>
                <c:formatCode>0.0</c:formatCode>
                <c:ptCount val="8"/>
                <c:pt idx="0">
                  <c:v>7.564999999999997</c:v>
                </c:pt>
                <c:pt idx="1">
                  <c:v>18.035</c:v>
                </c:pt>
                <c:pt idx="3">
                  <c:v>10.975</c:v>
                </c:pt>
                <c:pt idx="4">
                  <c:v>19.655</c:v>
                </c:pt>
                <c:pt idx="6">
                  <c:v>0.0</c:v>
                </c:pt>
                <c:pt idx="7">
                  <c:v>35.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6"/>
        <c:overlap val="100"/>
        <c:axId val="-642878496"/>
        <c:axId val="-642876176"/>
      </c:barChart>
      <c:catAx>
        <c:axId val="-642878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2876176"/>
        <c:crosses val="autoZero"/>
        <c:auto val="1"/>
        <c:lblAlgn val="ctr"/>
        <c:lblOffset val="100"/>
        <c:noMultiLvlLbl val="0"/>
      </c:catAx>
      <c:valAx>
        <c:axId val="-642876176"/>
        <c:scaling>
          <c:orientation val="minMax"/>
          <c:max val="110.0"/>
          <c:min val="0.0"/>
        </c:scaling>
        <c:delete val="0"/>
        <c:axPos val="l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2878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v>IgM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lasseur1.xlsx]Tri J1 rev'!$B$22:$I$22</c:f>
              <c:strCache>
                <c:ptCount val="8"/>
                <c:pt idx="0">
                  <c:v>FCRL4+ cells </c:v>
                </c:pt>
                <c:pt idx="1">
                  <c:v>FCRL4- cells</c:v>
                </c:pt>
                <c:pt idx="3">
                  <c:v>FCRL4+ cells </c:v>
                </c:pt>
                <c:pt idx="4">
                  <c:v>FCRL4- cells</c:v>
                </c:pt>
                <c:pt idx="6">
                  <c:v>FCRL4+ cells </c:v>
                </c:pt>
                <c:pt idx="7">
                  <c:v>FCRL4- cells</c:v>
                </c:pt>
              </c:strCache>
            </c:strRef>
          </c:cat>
          <c:val>
            <c:numRef>
              <c:f>'[Classeur1.xlsx]Tri J1 rev'!$B$23:$I$23</c:f>
              <c:numCache>
                <c:formatCode>0.0</c:formatCode>
                <c:ptCount val="8"/>
                <c:pt idx="0">
                  <c:v>50.395</c:v>
                </c:pt>
                <c:pt idx="1">
                  <c:v>27.275</c:v>
                </c:pt>
                <c:pt idx="3">
                  <c:v>36.23</c:v>
                </c:pt>
                <c:pt idx="4">
                  <c:v>29.075</c:v>
                </c:pt>
                <c:pt idx="6">
                  <c:v>0.0</c:v>
                </c:pt>
                <c:pt idx="7">
                  <c:v>16.035</c:v>
                </c:pt>
              </c:numCache>
            </c:numRef>
          </c:val>
        </c:ser>
        <c:ser>
          <c:idx val="1"/>
          <c:order val="1"/>
          <c:tx>
            <c:v>IgA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lasseur1.xlsx]Tri J1 rev'!$B$22:$I$22</c:f>
              <c:strCache>
                <c:ptCount val="8"/>
                <c:pt idx="0">
                  <c:v>FCRL4+ cells </c:v>
                </c:pt>
                <c:pt idx="1">
                  <c:v>FCRL4- cells</c:v>
                </c:pt>
                <c:pt idx="3">
                  <c:v>FCRL4+ cells </c:v>
                </c:pt>
                <c:pt idx="4">
                  <c:v>FCRL4- cells</c:v>
                </c:pt>
                <c:pt idx="6">
                  <c:v>FCRL4+ cells </c:v>
                </c:pt>
                <c:pt idx="7">
                  <c:v>FCRL4- cells</c:v>
                </c:pt>
              </c:strCache>
            </c:strRef>
          </c:cat>
          <c:val>
            <c:numRef>
              <c:f>'[Classeur1.xlsx]Tri J1 rev'!$B$24:$I$24</c:f>
              <c:numCache>
                <c:formatCode>0.0</c:formatCode>
                <c:ptCount val="8"/>
                <c:pt idx="0">
                  <c:v>31.185</c:v>
                </c:pt>
                <c:pt idx="1">
                  <c:v>32.47</c:v>
                </c:pt>
                <c:pt idx="3">
                  <c:v>56.485</c:v>
                </c:pt>
                <c:pt idx="4">
                  <c:v>35.985</c:v>
                </c:pt>
                <c:pt idx="6">
                  <c:v>0.0</c:v>
                </c:pt>
                <c:pt idx="7">
                  <c:v>29.45</c:v>
                </c:pt>
              </c:numCache>
            </c:numRef>
          </c:val>
        </c:ser>
        <c:ser>
          <c:idx val="2"/>
          <c:order val="2"/>
          <c:tx>
            <c:v>IgG</c:v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lasseur1.xlsx]Tri J1 rev'!$B$22:$I$22</c:f>
              <c:strCache>
                <c:ptCount val="8"/>
                <c:pt idx="0">
                  <c:v>FCRL4+ cells </c:v>
                </c:pt>
                <c:pt idx="1">
                  <c:v>FCRL4- cells</c:v>
                </c:pt>
                <c:pt idx="3">
                  <c:v>FCRL4+ cells </c:v>
                </c:pt>
                <c:pt idx="4">
                  <c:v>FCRL4- cells</c:v>
                </c:pt>
                <c:pt idx="6">
                  <c:v>FCRL4+ cells </c:v>
                </c:pt>
                <c:pt idx="7">
                  <c:v>FCRL4- cells</c:v>
                </c:pt>
              </c:strCache>
            </c:strRef>
          </c:cat>
          <c:val>
            <c:numRef>
              <c:f>'[Classeur1.xlsx]Tri J1 rev'!$B$25:$I$25</c:f>
              <c:numCache>
                <c:formatCode>0.0</c:formatCode>
                <c:ptCount val="8"/>
                <c:pt idx="0">
                  <c:v>14.745</c:v>
                </c:pt>
                <c:pt idx="1">
                  <c:v>35.515</c:v>
                </c:pt>
                <c:pt idx="3">
                  <c:v>8.215</c:v>
                </c:pt>
                <c:pt idx="4">
                  <c:v>33.415</c:v>
                </c:pt>
                <c:pt idx="6">
                  <c:v>0.0</c:v>
                </c:pt>
                <c:pt idx="7">
                  <c:v>49.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6"/>
        <c:overlap val="100"/>
        <c:axId val="-644735312"/>
        <c:axId val="-644054496"/>
      </c:barChart>
      <c:catAx>
        <c:axId val="-644735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4054496"/>
        <c:crosses val="autoZero"/>
        <c:auto val="1"/>
        <c:lblAlgn val="ctr"/>
        <c:lblOffset val="100"/>
        <c:noMultiLvlLbl val="0"/>
      </c:catAx>
      <c:valAx>
        <c:axId val="-644054496"/>
        <c:scaling>
          <c:orientation val="minMax"/>
          <c:max val="110.0"/>
          <c:min val="0.0"/>
        </c:scaling>
        <c:delete val="0"/>
        <c:axPos val="l"/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4735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931127461526"/>
          <c:y val="0.145054945054945"/>
          <c:w val="0.838710038294393"/>
          <c:h val="0.755172449597646"/>
        </c:manualLayout>
      </c:layout>
      <c:barChart>
        <c:barDir val="col"/>
        <c:grouping val="clustered"/>
        <c:varyColors val="0"/>
        <c:ser>
          <c:idx val="0"/>
          <c:order val="0"/>
          <c:tx>
            <c:v>D1-sorted FCRL4+ cells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lasseur1.xlsx]Tri J1 rev'!$K$49:$M$49</c:f>
                <c:numCache>
                  <c:formatCode>General</c:formatCode>
                  <c:ptCount val="3"/>
                  <c:pt idx="0">
                    <c:v>4.359999999999984</c:v>
                  </c:pt>
                  <c:pt idx="1">
                    <c:v>4.07000000000001</c:v>
                  </c:pt>
                  <c:pt idx="2">
                    <c:v>6.284999999999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lasseur1.xlsx]Tri J1 rev'!$K$45:$M$45</c:f>
              <c:strCache>
                <c:ptCount val="3"/>
                <c:pt idx="0">
                  <c:v>D4 prePBs</c:v>
                </c:pt>
                <c:pt idx="1">
                  <c:v>D7 PBs</c:v>
                </c:pt>
                <c:pt idx="2">
                  <c:v>D10 PCs</c:v>
                </c:pt>
              </c:strCache>
            </c:strRef>
          </c:cat>
          <c:val>
            <c:numRef>
              <c:f>'[Classeur1.xlsx]Tri J1 rev'!$K$48:$M$48</c:f>
              <c:numCache>
                <c:formatCode>0.0</c:formatCode>
                <c:ptCount val="3"/>
                <c:pt idx="0">
                  <c:v>42.43</c:v>
                </c:pt>
                <c:pt idx="1">
                  <c:v>40.35</c:v>
                </c:pt>
                <c:pt idx="2">
                  <c:v>30.035</c:v>
                </c:pt>
              </c:numCache>
            </c:numRef>
          </c:val>
        </c:ser>
        <c:ser>
          <c:idx val="1"/>
          <c:order val="1"/>
          <c:tx>
            <c:v>D1-sorted FCRL4 cells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lasseur1.xlsx]Tri J1 rev'!$K$55:$M$55</c:f>
                <c:numCache>
                  <c:formatCode>General</c:formatCode>
                  <c:ptCount val="3"/>
                  <c:pt idx="0">
                    <c:v>10.415</c:v>
                  </c:pt>
                  <c:pt idx="1">
                    <c:v>7.434999999999984</c:v>
                  </c:pt>
                  <c:pt idx="2">
                    <c:v>3.94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lasseur1.xlsx]Tri J1 rev'!$K$45:$M$45</c:f>
              <c:strCache>
                <c:ptCount val="3"/>
                <c:pt idx="0">
                  <c:v>D4 prePBs</c:v>
                </c:pt>
                <c:pt idx="1">
                  <c:v>D7 PBs</c:v>
                </c:pt>
                <c:pt idx="2">
                  <c:v>D10 PCs</c:v>
                </c:pt>
              </c:strCache>
            </c:strRef>
          </c:cat>
          <c:val>
            <c:numRef>
              <c:f>'[Classeur1.xlsx]Tri J1 rev'!$K$54:$M$54</c:f>
              <c:numCache>
                <c:formatCode>0.0</c:formatCode>
                <c:ptCount val="3"/>
                <c:pt idx="0">
                  <c:v>59.215</c:v>
                </c:pt>
                <c:pt idx="1">
                  <c:v>53.965</c:v>
                </c:pt>
                <c:pt idx="2">
                  <c:v>43.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644649136"/>
        <c:axId val="-714962128"/>
      </c:barChart>
      <c:catAx>
        <c:axId val="-64464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14962128"/>
        <c:crosses val="autoZero"/>
        <c:auto val="1"/>
        <c:lblAlgn val="ctr"/>
        <c:lblOffset val="100"/>
        <c:noMultiLvlLbl val="0"/>
      </c:catAx>
      <c:valAx>
        <c:axId val="-714962128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4649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6660ED-7B29-FB4D-9666-0C4CF6A9F28D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AC31AF-B6B1-F840-BE2D-80BA9088F6F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45782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49D194-607E-A24B-8651-B1C0A06ACA9E}" type="datetimeFigureOut">
              <a:rPr lang="fr-FR" smtClean="0"/>
              <a:t>02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A0E596-862A-9746-9960-6C3D3B4276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420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8" name="Graphique 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816955"/>
              </p:ext>
            </p:extLst>
          </p:nvPr>
        </p:nvGraphicFramePr>
        <p:xfrm>
          <a:off x="788148" y="6916171"/>
          <a:ext cx="2606400" cy="2386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6" name="Grouper 25"/>
          <p:cNvGrpSpPr/>
          <p:nvPr/>
        </p:nvGrpSpPr>
        <p:grpSpPr>
          <a:xfrm>
            <a:off x="4038750" y="822747"/>
            <a:ext cx="2482966" cy="454923"/>
            <a:chOff x="1988840" y="755576"/>
            <a:chExt cx="2482966" cy="454923"/>
          </a:xfrm>
        </p:grpSpPr>
        <p:sp>
          <p:nvSpPr>
            <p:cNvPr id="27" name="ZoneTexte 26"/>
            <p:cNvSpPr txBox="1"/>
            <p:nvPr/>
          </p:nvSpPr>
          <p:spPr>
            <a:xfrm>
              <a:off x="2023534" y="755576"/>
              <a:ext cx="24482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D1-sorted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FCRL4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cells</a:t>
              </a:r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1988840" y="933500"/>
              <a:ext cx="24829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D1-sorted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FCRL4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cells</a:t>
              </a:r>
            </a:p>
          </p:txBody>
        </p:sp>
        <p:sp>
          <p:nvSpPr>
            <p:cNvPr id="29" name="Rectangle 28"/>
            <p:cNvSpPr>
              <a:spLocks noChangeAspect="1"/>
            </p:cNvSpPr>
            <p:nvPr/>
          </p:nvSpPr>
          <p:spPr>
            <a:xfrm>
              <a:off x="2175416" y="826612"/>
              <a:ext cx="126000" cy="12600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" name="Rectangle 29"/>
            <p:cNvSpPr>
              <a:spLocks noChangeAspect="1"/>
            </p:cNvSpPr>
            <p:nvPr/>
          </p:nvSpPr>
          <p:spPr>
            <a:xfrm>
              <a:off x="2175416" y="1020458"/>
              <a:ext cx="126000" cy="126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31" name="ZoneTexte 30"/>
          <p:cNvSpPr txBox="1"/>
          <p:nvPr/>
        </p:nvSpPr>
        <p:spPr>
          <a:xfrm>
            <a:off x="1144651" y="9105620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cyIgM</a:t>
            </a:r>
          </a:p>
        </p:txBody>
      </p:sp>
      <p:sp>
        <p:nvSpPr>
          <p:cNvPr id="32" name="ZoneTexte 31"/>
          <p:cNvSpPr txBox="1"/>
          <p:nvPr/>
        </p:nvSpPr>
        <p:spPr>
          <a:xfrm>
            <a:off x="1872159" y="9105620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cyIgA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2566190" y="9105620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cyIgG</a:t>
            </a:r>
          </a:p>
        </p:txBody>
      </p:sp>
      <p:sp>
        <p:nvSpPr>
          <p:cNvPr id="34" name="Rectangle 33"/>
          <p:cNvSpPr/>
          <p:nvPr/>
        </p:nvSpPr>
        <p:spPr>
          <a:xfrm rot="16200000">
            <a:off x="-631541" y="7810716"/>
            <a:ext cx="24929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1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1200" dirty="0"/>
              <a:t>Cytoplasmic </a:t>
            </a:r>
            <a:r>
              <a:rPr lang="en-US" sz="1200" dirty="0" err="1"/>
              <a:t>Igs</a:t>
            </a:r>
            <a:r>
              <a:rPr lang="en-US" sz="1200" dirty="0"/>
              <a:t> in D10 PCs (%)</a:t>
            </a:r>
          </a:p>
        </p:txBody>
      </p:sp>
      <p:grpSp>
        <p:nvGrpSpPr>
          <p:cNvPr id="35" name="Grouper 34"/>
          <p:cNvGrpSpPr/>
          <p:nvPr/>
        </p:nvGrpSpPr>
        <p:grpSpPr>
          <a:xfrm>
            <a:off x="932784" y="6695911"/>
            <a:ext cx="2482966" cy="454923"/>
            <a:chOff x="1988840" y="755576"/>
            <a:chExt cx="2482966" cy="454923"/>
          </a:xfrm>
        </p:grpSpPr>
        <p:sp>
          <p:nvSpPr>
            <p:cNvPr id="36" name="ZoneTexte 35"/>
            <p:cNvSpPr txBox="1"/>
            <p:nvPr/>
          </p:nvSpPr>
          <p:spPr>
            <a:xfrm>
              <a:off x="2023534" y="755576"/>
              <a:ext cx="24482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D1-sorted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FCRL4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cells</a:t>
              </a:r>
            </a:p>
          </p:txBody>
        </p:sp>
        <p:sp>
          <p:nvSpPr>
            <p:cNvPr id="37" name="ZoneTexte 36"/>
            <p:cNvSpPr txBox="1"/>
            <p:nvPr/>
          </p:nvSpPr>
          <p:spPr>
            <a:xfrm>
              <a:off x="1988840" y="933500"/>
              <a:ext cx="24829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D1-sorted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FCRL4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cells</a:t>
              </a:r>
            </a:p>
          </p:txBody>
        </p:sp>
        <p:sp>
          <p:nvSpPr>
            <p:cNvPr id="38" name="Rectangle 37"/>
            <p:cNvSpPr>
              <a:spLocks noChangeAspect="1"/>
            </p:cNvSpPr>
            <p:nvPr/>
          </p:nvSpPr>
          <p:spPr>
            <a:xfrm>
              <a:off x="2175416" y="826612"/>
              <a:ext cx="126000" cy="12600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" name="Rectangle 38"/>
            <p:cNvSpPr>
              <a:spLocks noChangeAspect="1"/>
            </p:cNvSpPr>
            <p:nvPr/>
          </p:nvSpPr>
          <p:spPr>
            <a:xfrm>
              <a:off x="2175416" y="1020458"/>
              <a:ext cx="126000" cy="126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" name="Grouper 1"/>
          <p:cNvGrpSpPr/>
          <p:nvPr/>
        </p:nvGrpSpPr>
        <p:grpSpPr>
          <a:xfrm>
            <a:off x="1000231" y="816804"/>
            <a:ext cx="2506116" cy="644731"/>
            <a:chOff x="3856106" y="7670425"/>
            <a:chExt cx="2506116" cy="644731"/>
          </a:xfrm>
        </p:grpSpPr>
        <p:sp>
          <p:nvSpPr>
            <p:cNvPr id="41" name="ZoneTexte 40"/>
            <p:cNvSpPr txBox="1"/>
            <p:nvPr/>
          </p:nvSpPr>
          <p:spPr>
            <a:xfrm>
              <a:off x="3913950" y="7860233"/>
              <a:ext cx="24482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D1-sorted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FCRL4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cells</a:t>
              </a:r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3879256" y="8038157"/>
              <a:ext cx="24829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D1-sorted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FCRL4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cells</a:t>
              </a:r>
            </a:p>
          </p:txBody>
        </p:sp>
        <p:sp>
          <p:nvSpPr>
            <p:cNvPr id="43" name="Rectangle 42"/>
            <p:cNvSpPr>
              <a:spLocks noChangeAspect="1"/>
            </p:cNvSpPr>
            <p:nvPr/>
          </p:nvSpPr>
          <p:spPr>
            <a:xfrm>
              <a:off x="4065832" y="7931269"/>
              <a:ext cx="126000" cy="12600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4" name="Rectangle 43"/>
            <p:cNvSpPr>
              <a:spLocks noChangeAspect="1"/>
            </p:cNvSpPr>
            <p:nvPr/>
          </p:nvSpPr>
          <p:spPr>
            <a:xfrm>
              <a:off x="4065832" y="8125115"/>
              <a:ext cx="126000" cy="126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3856106" y="7670425"/>
              <a:ext cx="21723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D1-unsorted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cells</a:t>
              </a:r>
            </a:p>
          </p:txBody>
        </p:sp>
        <p:sp>
          <p:nvSpPr>
            <p:cNvPr id="46" name="Rectangle 45"/>
            <p:cNvSpPr>
              <a:spLocks noChangeAspect="1"/>
            </p:cNvSpPr>
            <p:nvPr/>
          </p:nvSpPr>
          <p:spPr>
            <a:xfrm>
              <a:off x="4067751" y="7745078"/>
              <a:ext cx="126000" cy="126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47" name="Rectangle 46"/>
          <p:cNvSpPr/>
          <p:nvPr/>
        </p:nvSpPr>
        <p:spPr>
          <a:xfrm rot="16200000">
            <a:off x="-169668" y="2059189"/>
            <a:ext cx="1431369" cy="275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800" b="1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1200" dirty="0" smtClean="0"/>
              <a:t>FCRL4+ cells (%)</a:t>
            </a:r>
            <a:endParaRPr lang="en-US" sz="1200" dirty="0"/>
          </a:p>
        </p:txBody>
      </p:sp>
      <p:sp>
        <p:nvSpPr>
          <p:cNvPr id="48" name="ZoneTexte 47"/>
          <p:cNvSpPr txBox="1"/>
          <p:nvPr/>
        </p:nvSpPr>
        <p:spPr>
          <a:xfrm>
            <a:off x="520922" y="2972533"/>
            <a:ext cx="1203647" cy="643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1-</a:t>
            </a:r>
          </a:p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unsorted cells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1598129" y="2971185"/>
            <a:ext cx="378845" cy="2759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1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1912579" y="2971185"/>
            <a:ext cx="378845" cy="2759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4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2225093" y="2971185"/>
            <a:ext cx="378845" cy="2759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7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2530160" y="2971185"/>
            <a:ext cx="463495" cy="2759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smtClean="0">
                <a:latin typeface="Arial" pitchFamily="34" charset="0"/>
                <a:cs typeface="Arial" pitchFamily="34" charset="0"/>
              </a:rPr>
              <a:t>D10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4122081" y="2967777"/>
            <a:ext cx="719039" cy="459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4</a:t>
            </a:r>
          </a:p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prePBs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4936176" y="2967778"/>
            <a:ext cx="481063" cy="4599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7</a:t>
            </a:r>
          </a:p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PBs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5623445" y="2967778"/>
            <a:ext cx="481062" cy="4599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10</a:t>
            </a:r>
          </a:p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PCs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 rot="16200000">
            <a:off x="3292252" y="1929159"/>
            <a:ext cx="830839" cy="275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800" b="1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1200" dirty="0" smtClean="0"/>
              <a:t>Cells (%)</a:t>
            </a:r>
            <a:endParaRPr lang="en-US" sz="1200" dirty="0"/>
          </a:p>
        </p:txBody>
      </p:sp>
      <p:sp>
        <p:nvSpPr>
          <p:cNvPr id="64" name="ZoneTexte 63"/>
          <p:cNvSpPr txBox="1"/>
          <p:nvPr/>
        </p:nvSpPr>
        <p:spPr>
          <a:xfrm>
            <a:off x="4039418" y="3727826"/>
            <a:ext cx="2335912" cy="306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D1-sorted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FCRL4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-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cells</a:t>
            </a:r>
          </a:p>
        </p:txBody>
      </p:sp>
      <p:sp>
        <p:nvSpPr>
          <p:cNvPr id="65" name="ZoneTexte 64"/>
          <p:cNvSpPr txBox="1"/>
          <p:nvPr/>
        </p:nvSpPr>
        <p:spPr>
          <a:xfrm>
            <a:off x="682596" y="3727826"/>
            <a:ext cx="2473907" cy="306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D1-sorted FCRL4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cells</a:t>
            </a:r>
          </a:p>
        </p:txBody>
      </p:sp>
      <p:grpSp>
        <p:nvGrpSpPr>
          <p:cNvPr id="13" name="Grouper 12"/>
          <p:cNvGrpSpPr/>
          <p:nvPr/>
        </p:nvGrpSpPr>
        <p:grpSpPr>
          <a:xfrm>
            <a:off x="2952895" y="4443858"/>
            <a:ext cx="1160396" cy="276999"/>
            <a:chOff x="2797046" y="3887616"/>
            <a:chExt cx="1160396" cy="276999"/>
          </a:xfrm>
        </p:grpSpPr>
        <p:sp>
          <p:nvSpPr>
            <p:cNvPr id="67" name="ZoneTexte 66"/>
            <p:cNvSpPr txBox="1"/>
            <p:nvPr/>
          </p:nvSpPr>
          <p:spPr>
            <a:xfrm>
              <a:off x="2830884" y="3887616"/>
              <a:ext cx="11265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cyIGM</a:t>
              </a:r>
              <a:r>
                <a:rPr lang="en-US" sz="1200" b="1" baseline="30000" dirty="0" smtClean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cells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Rectangle 68"/>
            <p:cNvSpPr>
              <a:spLocks/>
            </p:cNvSpPr>
            <p:nvPr/>
          </p:nvSpPr>
          <p:spPr>
            <a:xfrm>
              <a:off x="2797046" y="3960722"/>
              <a:ext cx="129600" cy="12960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40" name="Grouper 39"/>
          <p:cNvGrpSpPr/>
          <p:nvPr/>
        </p:nvGrpSpPr>
        <p:grpSpPr>
          <a:xfrm>
            <a:off x="2945990" y="4698956"/>
            <a:ext cx="1208043" cy="276999"/>
            <a:chOff x="2808621" y="4269160"/>
            <a:chExt cx="1208043" cy="276999"/>
          </a:xfrm>
        </p:grpSpPr>
        <p:sp>
          <p:nvSpPr>
            <p:cNvPr id="68" name="ZoneTexte 67"/>
            <p:cNvSpPr txBox="1"/>
            <p:nvPr/>
          </p:nvSpPr>
          <p:spPr>
            <a:xfrm>
              <a:off x="2830883" y="4269160"/>
              <a:ext cx="11857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cyIgA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cells</a:t>
              </a:r>
            </a:p>
          </p:txBody>
        </p:sp>
        <p:sp>
          <p:nvSpPr>
            <p:cNvPr id="70" name="Rectangle 69"/>
            <p:cNvSpPr>
              <a:spLocks/>
            </p:cNvSpPr>
            <p:nvPr/>
          </p:nvSpPr>
          <p:spPr>
            <a:xfrm>
              <a:off x="2808621" y="4363288"/>
              <a:ext cx="129600" cy="1296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73" name="Grouper 72"/>
          <p:cNvGrpSpPr/>
          <p:nvPr/>
        </p:nvGrpSpPr>
        <p:grpSpPr>
          <a:xfrm>
            <a:off x="2952895" y="4963593"/>
            <a:ext cx="1182801" cy="276999"/>
            <a:chOff x="2808621" y="4485293"/>
            <a:chExt cx="1182801" cy="276999"/>
          </a:xfrm>
        </p:grpSpPr>
        <p:sp>
          <p:nvSpPr>
            <p:cNvPr id="71" name="ZoneTexte 70"/>
            <p:cNvSpPr txBox="1"/>
            <p:nvPr/>
          </p:nvSpPr>
          <p:spPr>
            <a:xfrm>
              <a:off x="2830883" y="4485293"/>
              <a:ext cx="11605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cyIgG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cells</a:t>
              </a:r>
            </a:p>
          </p:txBody>
        </p:sp>
        <p:sp>
          <p:nvSpPr>
            <p:cNvPr id="72" name="Rectangle 71"/>
            <p:cNvSpPr>
              <a:spLocks/>
            </p:cNvSpPr>
            <p:nvPr/>
          </p:nvSpPr>
          <p:spPr>
            <a:xfrm>
              <a:off x="2808621" y="4573511"/>
              <a:ext cx="129600" cy="1296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75" name="ZoneTexte 74"/>
          <p:cNvSpPr txBox="1"/>
          <p:nvPr/>
        </p:nvSpPr>
        <p:spPr>
          <a:xfrm>
            <a:off x="1019841" y="615807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4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ZoneTexte 75"/>
          <p:cNvSpPr txBox="1"/>
          <p:nvPr/>
        </p:nvSpPr>
        <p:spPr>
          <a:xfrm>
            <a:off x="1698506" y="615807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7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ZoneTexte 76"/>
          <p:cNvSpPr txBox="1"/>
          <p:nvPr/>
        </p:nvSpPr>
        <p:spPr>
          <a:xfrm>
            <a:off x="2286198" y="6158070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smtClean="0">
                <a:latin typeface="Arial" pitchFamily="34" charset="0"/>
                <a:cs typeface="Arial" pitchFamily="34" charset="0"/>
              </a:rPr>
              <a:t>D10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Rectangle 80"/>
          <p:cNvSpPr/>
          <p:nvPr/>
        </p:nvSpPr>
        <p:spPr>
          <a:xfrm rot="16200000">
            <a:off x="-277791" y="4857565"/>
            <a:ext cx="16466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1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1200" dirty="0"/>
              <a:t>Cytoplasmic </a:t>
            </a:r>
            <a:r>
              <a:rPr lang="en-US" sz="1200" dirty="0" err="1" smtClean="0"/>
              <a:t>Igs</a:t>
            </a:r>
            <a:r>
              <a:rPr lang="en-US" sz="1200" dirty="0" smtClean="0"/>
              <a:t> </a:t>
            </a:r>
            <a:r>
              <a:rPr lang="en-US" sz="1200" dirty="0"/>
              <a:t>(%)</a:t>
            </a:r>
          </a:p>
        </p:txBody>
      </p:sp>
      <p:sp>
        <p:nvSpPr>
          <p:cNvPr id="82" name="ZoneTexte 81"/>
          <p:cNvSpPr txBox="1"/>
          <p:nvPr/>
        </p:nvSpPr>
        <p:spPr>
          <a:xfrm>
            <a:off x="254643" y="55558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 charset="0"/>
                <a:ea typeface="Arial" charset="0"/>
                <a:cs typeface="Arial" charset="0"/>
              </a:rPr>
              <a:t>A</a:t>
            </a:r>
            <a:endParaRPr lang="fr-FR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3449351" y="542649"/>
            <a:ext cx="401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84" name="ZoneTexte 83"/>
          <p:cNvSpPr txBox="1"/>
          <p:nvPr/>
        </p:nvSpPr>
        <p:spPr>
          <a:xfrm>
            <a:off x="254643" y="3597857"/>
            <a:ext cx="350096" cy="367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85" name="ZoneTexte 84"/>
          <p:cNvSpPr txBox="1"/>
          <p:nvPr/>
        </p:nvSpPr>
        <p:spPr>
          <a:xfrm>
            <a:off x="3450741" y="3542249"/>
            <a:ext cx="379603" cy="36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 charset="0"/>
                <a:ea typeface="Arial" charset="0"/>
                <a:cs typeface="Arial" charset="0"/>
              </a:rPr>
              <a:t>D</a:t>
            </a:r>
            <a:endParaRPr lang="fr-FR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255290" y="651525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 charset="0"/>
                <a:ea typeface="Arial" charset="0"/>
                <a:cs typeface="Arial" charset="0"/>
              </a:rPr>
              <a:t>E</a:t>
            </a:r>
            <a:endParaRPr lang="fr-FR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4372958" y="615807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4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ZoneTexte 73"/>
          <p:cNvSpPr txBox="1"/>
          <p:nvPr/>
        </p:nvSpPr>
        <p:spPr>
          <a:xfrm>
            <a:off x="5051623" y="615807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7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ZoneTexte 86"/>
          <p:cNvSpPr txBox="1"/>
          <p:nvPr/>
        </p:nvSpPr>
        <p:spPr>
          <a:xfrm>
            <a:off x="5639315" y="6158070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smtClean="0">
                <a:latin typeface="Arial" pitchFamily="34" charset="0"/>
                <a:cs typeface="Arial" pitchFamily="34" charset="0"/>
              </a:rPr>
              <a:t>D10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2" name="Graphique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2943355"/>
              </p:ext>
            </p:extLst>
          </p:nvPr>
        </p:nvGraphicFramePr>
        <p:xfrm>
          <a:off x="634550" y="1140495"/>
          <a:ext cx="2496458" cy="1976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3" name="Graphique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9879547"/>
              </p:ext>
            </p:extLst>
          </p:nvPr>
        </p:nvGraphicFramePr>
        <p:xfrm>
          <a:off x="588020" y="3894208"/>
          <a:ext cx="2368800" cy="239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0" name="Graphique 7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8298851"/>
              </p:ext>
            </p:extLst>
          </p:nvPr>
        </p:nvGraphicFramePr>
        <p:xfrm>
          <a:off x="3914066" y="3908036"/>
          <a:ext cx="2368800" cy="239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9" name="Graphique 8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8953183"/>
              </p:ext>
            </p:extLst>
          </p:nvPr>
        </p:nvGraphicFramePr>
        <p:xfrm>
          <a:off x="3830344" y="851959"/>
          <a:ext cx="2505600" cy="232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" name="ZoneTexte 3"/>
          <p:cNvSpPr txBox="1"/>
          <p:nvPr/>
        </p:nvSpPr>
        <p:spPr>
          <a:xfrm>
            <a:off x="4421525" y="119046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/>
              <a:t>*</a:t>
            </a:r>
          </a:p>
        </p:txBody>
      </p:sp>
      <p:sp>
        <p:nvSpPr>
          <p:cNvPr id="78" name="ZoneTexte 77"/>
          <p:cNvSpPr txBox="1"/>
          <p:nvPr/>
        </p:nvSpPr>
        <p:spPr>
          <a:xfrm>
            <a:off x="5117937" y="134286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/>
              <a:t>*</a:t>
            </a:r>
          </a:p>
        </p:txBody>
      </p:sp>
      <p:sp>
        <p:nvSpPr>
          <p:cNvPr id="79" name="ZoneTexte 78"/>
          <p:cNvSpPr txBox="1"/>
          <p:nvPr/>
        </p:nvSpPr>
        <p:spPr>
          <a:xfrm>
            <a:off x="5812416" y="164381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/>
              <a:t>*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1424504" y="83685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90" name="ZoneTexte 89"/>
          <p:cNvSpPr txBox="1"/>
          <p:nvPr/>
        </p:nvSpPr>
        <p:spPr>
          <a:xfrm>
            <a:off x="2826971" y="706248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*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396189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3</TotalTime>
  <Words>86</Words>
  <Application>Microsoft Macintosh PowerPoint</Application>
  <PresentationFormat>Format A4 (210 x 297 mm)</PresentationFormat>
  <Paragraphs>4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hel</dc:creator>
  <cp:lastModifiedBy>Michel JOURDAN</cp:lastModifiedBy>
  <cp:revision>46</cp:revision>
  <cp:lastPrinted>2017-06-02T12:46:55Z</cp:lastPrinted>
  <dcterms:created xsi:type="dcterms:W3CDTF">2016-12-21T11:01:32Z</dcterms:created>
  <dcterms:modified xsi:type="dcterms:W3CDTF">2017-06-02T16:05:46Z</dcterms:modified>
</cp:coreProperties>
</file>